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9" r:id="rId2"/>
    <p:sldId id="27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9DD252B-1CCB-52D1-5007-112F3E5054F3}" name="Gueldner, Pete" initials="PG" userId="S::PHG15@pitt.edu::7a7fd809-3dcf-40c1-ab8f-9b513b456801" providerId="AD"/>
  <p188:author id="{DBA7AA79-18B7-C9C5-55D4-1BFBC5DF6A36}" name="Kerr, Kat" initials="KK" userId="S::KAK488@pitt.edu::cdeaa2f8-de64-4805-b8a4-2432fe197336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94040"/>
    <a:srgbClr val="00C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973" autoAdjust="0"/>
    <p:restoredTop sz="94658"/>
  </p:normalViewPr>
  <p:slideViewPr>
    <p:cSldViewPr snapToGrid="0">
      <p:cViewPr varScale="1">
        <p:scale>
          <a:sx n="150" d="100"/>
          <a:sy n="150" d="100"/>
        </p:scale>
        <p:origin x="324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8/10/relationships/authors" Target="authors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err, Kat" userId="cdeaa2f8-de64-4805-b8a4-2432fe197336" providerId="ADAL" clId="{D41738E9-F836-40D2-AECA-54E37AF30298}"/>
    <pc:docChg chg="custSel delSld modSld sldOrd">
      <pc:chgData name="Kerr, Kat" userId="cdeaa2f8-de64-4805-b8a4-2432fe197336" providerId="ADAL" clId="{D41738E9-F836-40D2-AECA-54E37AF30298}" dt="2025-03-11T18:53:07.521" v="22" actId="2711"/>
      <pc:docMkLst>
        <pc:docMk/>
      </pc:docMkLst>
      <pc:sldChg chg="addSp delSp modSp del mod">
        <pc:chgData name="Kerr, Kat" userId="cdeaa2f8-de64-4805-b8a4-2432fe197336" providerId="ADAL" clId="{D41738E9-F836-40D2-AECA-54E37AF30298}" dt="2025-02-25T15:16:39.232" v="1" actId="47"/>
        <pc:sldMkLst>
          <pc:docMk/>
          <pc:sldMk cId="604042530" sldId="256"/>
        </pc:sldMkLst>
      </pc:sldChg>
      <pc:sldChg chg="del ord">
        <pc:chgData name="Kerr, Kat" userId="cdeaa2f8-de64-4805-b8a4-2432fe197336" providerId="ADAL" clId="{D41738E9-F836-40D2-AECA-54E37AF30298}" dt="2025-02-25T15:16:41.907" v="4" actId="47"/>
        <pc:sldMkLst>
          <pc:docMk/>
          <pc:sldMk cId="2877649566" sldId="258"/>
        </pc:sldMkLst>
      </pc:sldChg>
      <pc:sldChg chg="del">
        <pc:chgData name="Kerr, Kat" userId="cdeaa2f8-de64-4805-b8a4-2432fe197336" providerId="ADAL" clId="{D41738E9-F836-40D2-AECA-54E37AF30298}" dt="2025-02-25T15:16:42.404" v="5" actId="47"/>
        <pc:sldMkLst>
          <pc:docMk/>
          <pc:sldMk cId="881087299" sldId="259"/>
        </pc:sldMkLst>
      </pc:sldChg>
      <pc:sldChg chg="del">
        <pc:chgData name="Kerr, Kat" userId="cdeaa2f8-de64-4805-b8a4-2432fe197336" providerId="ADAL" clId="{D41738E9-F836-40D2-AECA-54E37AF30298}" dt="2025-02-25T15:16:42.814" v="6" actId="47"/>
        <pc:sldMkLst>
          <pc:docMk/>
          <pc:sldMk cId="3215311124" sldId="260"/>
        </pc:sldMkLst>
      </pc:sldChg>
      <pc:sldChg chg="del">
        <pc:chgData name="Kerr, Kat" userId="cdeaa2f8-de64-4805-b8a4-2432fe197336" providerId="ADAL" clId="{D41738E9-F836-40D2-AECA-54E37AF30298}" dt="2025-02-25T15:16:43.373" v="7" actId="47"/>
        <pc:sldMkLst>
          <pc:docMk/>
          <pc:sldMk cId="1168517382" sldId="261"/>
        </pc:sldMkLst>
      </pc:sldChg>
      <pc:sldChg chg="del">
        <pc:chgData name="Kerr, Kat" userId="cdeaa2f8-de64-4805-b8a4-2432fe197336" providerId="ADAL" clId="{D41738E9-F836-40D2-AECA-54E37AF30298}" dt="2025-02-25T15:16:43.819" v="8" actId="47"/>
        <pc:sldMkLst>
          <pc:docMk/>
          <pc:sldMk cId="2967766263" sldId="262"/>
        </pc:sldMkLst>
      </pc:sldChg>
      <pc:sldChg chg="del">
        <pc:chgData name="Kerr, Kat" userId="cdeaa2f8-de64-4805-b8a4-2432fe197336" providerId="ADAL" clId="{D41738E9-F836-40D2-AECA-54E37AF30298}" dt="2025-02-25T15:16:44.175" v="9" actId="47"/>
        <pc:sldMkLst>
          <pc:docMk/>
          <pc:sldMk cId="3356615634" sldId="263"/>
        </pc:sldMkLst>
      </pc:sldChg>
      <pc:sldChg chg="del">
        <pc:chgData name="Kerr, Kat" userId="cdeaa2f8-de64-4805-b8a4-2432fe197336" providerId="ADAL" clId="{D41738E9-F836-40D2-AECA-54E37AF30298}" dt="2025-02-25T15:16:44.633" v="10" actId="47"/>
        <pc:sldMkLst>
          <pc:docMk/>
          <pc:sldMk cId="306015992" sldId="264"/>
        </pc:sldMkLst>
      </pc:sldChg>
      <pc:sldChg chg="del">
        <pc:chgData name="Kerr, Kat" userId="cdeaa2f8-de64-4805-b8a4-2432fe197336" providerId="ADAL" clId="{D41738E9-F836-40D2-AECA-54E37AF30298}" dt="2025-02-25T15:16:45.084" v="11" actId="47"/>
        <pc:sldMkLst>
          <pc:docMk/>
          <pc:sldMk cId="2209410811" sldId="265"/>
        </pc:sldMkLst>
      </pc:sldChg>
      <pc:sldChg chg="del">
        <pc:chgData name="Kerr, Kat" userId="cdeaa2f8-de64-4805-b8a4-2432fe197336" providerId="ADAL" clId="{D41738E9-F836-40D2-AECA-54E37AF30298}" dt="2025-02-25T15:16:45.399" v="12" actId="47"/>
        <pc:sldMkLst>
          <pc:docMk/>
          <pc:sldMk cId="1213123531" sldId="266"/>
        </pc:sldMkLst>
      </pc:sldChg>
      <pc:sldChg chg="del">
        <pc:chgData name="Kerr, Kat" userId="cdeaa2f8-de64-4805-b8a4-2432fe197336" providerId="ADAL" clId="{D41738E9-F836-40D2-AECA-54E37AF30298}" dt="2025-02-25T15:16:46.188" v="14" actId="47"/>
        <pc:sldMkLst>
          <pc:docMk/>
          <pc:sldMk cId="2398732004" sldId="268"/>
        </pc:sldMkLst>
      </pc:sldChg>
      <pc:sldChg chg="modSp mod">
        <pc:chgData name="Kerr, Kat" userId="cdeaa2f8-de64-4805-b8a4-2432fe197336" providerId="ADAL" clId="{D41738E9-F836-40D2-AECA-54E37AF30298}" dt="2025-03-11T18:53:02.729" v="21" actId="2711"/>
        <pc:sldMkLst>
          <pc:docMk/>
          <pc:sldMk cId="3396518868" sldId="269"/>
        </pc:sldMkLst>
        <pc:spChg chg="mod">
          <ac:chgData name="Kerr, Kat" userId="cdeaa2f8-de64-4805-b8a4-2432fe197336" providerId="ADAL" clId="{D41738E9-F836-40D2-AECA-54E37AF30298}" dt="2025-03-11T18:53:02.729" v="21" actId="2711"/>
          <ac:spMkLst>
            <pc:docMk/>
            <pc:sldMk cId="3396518868" sldId="269"/>
            <ac:spMk id="2" creationId="{C2E27A94-B4C8-2B81-4597-9DC042C1784C}"/>
          </ac:spMkLst>
        </pc:spChg>
        <pc:graphicFrameChg chg="modGraphic">
          <ac:chgData name="Kerr, Kat" userId="cdeaa2f8-de64-4805-b8a4-2432fe197336" providerId="ADAL" clId="{D41738E9-F836-40D2-AECA-54E37AF30298}" dt="2025-02-25T15:47:17.247" v="20" actId="20577"/>
          <ac:graphicFrameMkLst>
            <pc:docMk/>
            <pc:sldMk cId="3396518868" sldId="269"/>
            <ac:graphicFrameMk id="4" creationId="{6B6BA981-2915-E836-AD87-AC30A321D523}"/>
          </ac:graphicFrameMkLst>
        </pc:graphicFrameChg>
      </pc:sldChg>
      <pc:sldChg chg="del">
        <pc:chgData name="Kerr, Kat" userId="cdeaa2f8-de64-4805-b8a4-2432fe197336" providerId="ADAL" clId="{D41738E9-F836-40D2-AECA-54E37AF30298}" dt="2025-02-25T15:16:47.736" v="17" actId="47"/>
        <pc:sldMkLst>
          <pc:docMk/>
          <pc:sldMk cId="1816413354" sldId="270"/>
        </pc:sldMkLst>
      </pc:sldChg>
      <pc:sldChg chg="del">
        <pc:chgData name="Kerr, Kat" userId="cdeaa2f8-de64-4805-b8a4-2432fe197336" providerId="ADAL" clId="{D41738E9-F836-40D2-AECA-54E37AF30298}" dt="2025-02-25T15:16:48.194" v="18" actId="47"/>
        <pc:sldMkLst>
          <pc:docMk/>
          <pc:sldMk cId="1681110696" sldId="271"/>
        </pc:sldMkLst>
      </pc:sldChg>
      <pc:sldChg chg="del">
        <pc:chgData name="Kerr, Kat" userId="cdeaa2f8-de64-4805-b8a4-2432fe197336" providerId="ADAL" clId="{D41738E9-F836-40D2-AECA-54E37AF30298}" dt="2025-02-25T15:16:48.913" v="19" actId="47"/>
        <pc:sldMkLst>
          <pc:docMk/>
          <pc:sldMk cId="2390577539" sldId="272"/>
        </pc:sldMkLst>
      </pc:sldChg>
      <pc:sldChg chg="del">
        <pc:chgData name="Kerr, Kat" userId="cdeaa2f8-de64-4805-b8a4-2432fe197336" providerId="ADAL" clId="{D41738E9-F836-40D2-AECA-54E37AF30298}" dt="2025-02-25T15:16:45.820" v="13" actId="47"/>
        <pc:sldMkLst>
          <pc:docMk/>
          <pc:sldMk cId="3836955635" sldId="274"/>
        </pc:sldMkLst>
      </pc:sldChg>
      <pc:sldChg chg="del">
        <pc:chgData name="Kerr, Kat" userId="cdeaa2f8-de64-4805-b8a4-2432fe197336" providerId="ADAL" clId="{D41738E9-F836-40D2-AECA-54E37AF30298}" dt="2025-02-25T15:16:46.920" v="16" actId="47"/>
        <pc:sldMkLst>
          <pc:docMk/>
          <pc:sldMk cId="940257840" sldId="275"/>
        </pc:sldMkLst>
      </pc:sldChg>
      <pc:sldChg chg="modSp mod">
        <pc:chgData name="Kerr, Kat" userId="cdeaa2f8-de64-4805-b8a4-2432fe197336" providerId="ADAL" clId="{D41738E9-F836-40D2-AECA-54E37AF30298}" dt="2025-03-11T18:53:07.521" v="22" actId="2711"/>
        <pc:sldMkLst>
          <pc:docMk/>
          <pc:sldMk cId="2961209921" sldId="276"/>
        </pc:sldMkLst>
        <pc:spChg chg="mod">
          <ac:chgData name="Kerr, Kat" userId="cdeaa2f8-de64-4805-b8a4-2432fe197336" providerId="ADAL" clId="{D41738E9-F836-40D2-AECA-54E37AF30298}" dt="2025-03-11T18:53:07.521" v="22" actId="2711"/>
          <ac:spMkLst>
            <pc:docMk/>
            <pc:sldMk cId="2961209921" sldId="276"/>
            <ac:spMk id="2" creationId="{173F2890-4CAD-EFBC-1B7A-AE099D655EBE}"/>
          </ac:spMkLst>
        </pc:spChg>
      </pc:sldChg>
      <pc:sldChg chg="del">
        <pc:chgData name="Kerr, Kat" userId="cdeaa2f8-de64-4805-b8a4-2432fe197336" providerId="ADAL" clId="{D41738E9-F836-40D2-AECA-54E37AF30298}" dt="2025-02-25T15:16:46.522" v="15" actId="47"/>
        <pc:sldMkLst>
          <pc:docMk/>
          <pc:sldMk cId="199652766" sldId="277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C14CEC-3A1B-40F7-AD17-76E90EA4CC46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866EC36-70E2-4790-BED8-3BF566DDA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62377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74D5E0-B966-180A-1268-A9F98F9A938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6931A67-1BE0-A6EC-3B33-E2F92D2D0AD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0D58A1-C535-77C9-1E80-1D0C0D9187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A4FF-BAD2-4E8D-B383-4BF5D3F8A13B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D22F9A-78B8-0CAB-909A-5C25536149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E35153-8FD0-2CB8-B5B9-F6E7EC0019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E5290-F301-4B91-BD00-3FA05D4FDC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18474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9C8F00-6493-FD86-3EF6-8E90569152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EEF8ACF-14C3-2269-6E60-DA1DFB36D5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234824-D542-2CD9-DF0C-7BB121D131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A4FF-BAD2-4E8D-B383-4BF5D3F8A13B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740B20-6A58-2170-7622-FFF4FC441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EB32A2-4C61-778D-F639-A49A1E51D9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E5290-F301-4B91-BD00-3FA05D4FDC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71219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00BD581-0535-FC9C-D23C-54BFF320223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281B77B-7488-3CC3-6A2E-13F78DC12E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775907-FC41-8D3B-2FDE-2958D81978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A4FF-BAD2-4E8D-B383-4BF5D3F8A13B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3E085A-AD29-0899-1C39-76EF7573F5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F88E76-A7ED-0E12-2A05-24DB356D6D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E5290-F301-4B91-BD00-3FA05D4FDC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08987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7F23EE-117E-55B9-8896-30AF596062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4C5143-72FC-8327-D9C7-C29EF06F2A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F9FBF3-E62D-505B-E6F4-6E8E2B3C7B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A4FF-BAD2-4E8D-B383-4BF5D3F8A13B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F1FA3C-5D0D-32EB-5872-4A125D92C5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DDE6B4-763F-2FC1-927C-FF217A6D36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E5290-F301-4B91-BD00-3FA05D4FDC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78584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EAE54F-232F-5E47-ECC7-CC8489636C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86815A-8251-BBEE-2961-9CF2E50B95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BFB348-2E20-E34D-F6F3-1080152072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A4FF-BAD2-4E8D-B383-4BF5D3F8A13B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028EB2-73EF-567B-E35F-831C1F7157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9E78DB-9405-126A-F23F-E52E0A6A09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E5290-F301-4B91-BD00-3FA05D4FDC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5915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ADA5D7-A53C-4DC0-A5E8-FD66897588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4B7F10-C3C2-94E4-0B85-DA9F9D2081F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5FE0716-9F9F-1721-B428-8C6BD32591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B98A14F-C5E1-F398-11F7-172C620AB7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A4FF-BAD2-4E8D-B383-4BF5D3F8A13B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70C832-33EC-5AF7-4B7B-A6B57685E1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645775-83B3-991D-ACC3-B8D9BD396E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E5290-F301-4B91-BD00-3FA05D4FDC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77244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9FCD3E-19D4-747D-7562-E5CA1903D3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DF7FCE3-C08B-23F1-D08C-AFDCB86D52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047D249-F89A-30EC-76D9-E45FE0150F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C505C05-DC36-7BE6-21DB-5BEBA10EE9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044137D-99D0-BBAB-BDD0-E808BA849E7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5B5247B-EE4B-2CF2-B2C1-C7FCF906A1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A4FF-BAD2-4E8D-B383-4BF5D3F8A13B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BF61929-B0C4-A137-6B22-BE8FB48930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F17F3EC-46F8-D237-E00D-FB1547B6D0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E5290-F301-4B91-BD00-3FA05D4FDC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59217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A5BB96-B3AB-5C24-F2A3-0D1657E06B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06E49CD-EAE6-D762-2DCB-9A10A1AD9A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A4FF-BAD2-4E8D-B383-4BF5D3F8A13B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C1F311D-17ED-4D99-1E37-DB9F4E2583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ABFCDB2-C2A4-F383-DC7B-81279966C0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E5290-F301-4B91-BD00-3FA05D4FDC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33950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FE32B87-C0FE-74E8-8AB8-93438709D6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A4FF-BAD2-4E8D-B383-4BF5D3F8A13B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7BDCAC9-3E31-72C3-F552-ECA000D2D1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AA91296-22DA-0CD8-F28D-B422298666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E5290-F301-4B91-BD00-3FA05D4FDC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7664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DFA145-10E1-807D-04D0-C714639CB6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20F08A-221A-97EE-5C26-57C699F6DC0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2B31E3-6C34-E751-9F86-2CE2D60219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BB2D20-AD04-58E5-134B-217053D97B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A4FF-BAD2-4E8D-B383-4BF5D3F8A13B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52DC14F-4674-BA42-96FB-3207226C84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62DD7BE-BF7E-057D-716C-C33FD38A36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E5290-F301-4B91-BD00-3FA05D4FDC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91421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7915E0-1C94-119A-AE31-85ED88EE70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AFF4AF3-35D6-C135-1454-6489168E4FF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C1F2821-E1E2-54C5-7E5A-64B153FC1A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68E1F4-FC91-44AC-FA80-CA3156B098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A4FF-BAD2-4E8D-B383-4BF5D3F8A13B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6C788BB-7376-5DB5-402C-51200CDC80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D43E21-81D8-EE80-2B4C-2E7DD1C939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E5290-F301-4B91-BD00-3FA05D4FDC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71618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B51AAA4-3205-CA48-2851-8D6BEEC57E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4827A83-CB8E-FAB6-D28A-BA1855B53E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08C813-CAF6-9CD0-FA0E-A6B42B036C4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ED9A4FF-BAD2-4E8D-B383-4BF5D3F8A13B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143A5E-5102-D79C-FAE7-31087AD477C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90E9E7-FA1A-3113-F042-44108F3B0C2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5BE5290-F301-4B91-BD00-3FA05D4FDC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34957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E27A94-B4C8-2B81-4597-9DC042C178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Table 1: Three Outcomes Testing Results</a:t>
            </a:r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6B6BA981-2915-E836-AD87-AC30A321D523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32750600"/>
              </p:ext>
            </p:extLst>
          </p:nvPr>
        </p:nvGraphicFramePr>
        <p:xfrm>
          <a:off x="838200" y="1690688"/>
          <a:ext cx="10515600" cy="4560332"/>
        </p:xfrm>
        <a:graphic>
          <a:graphicData uri="http://schemas.openxmlformats.org/drawingml/2006/table">
            <a:tbl>
              <a:tblPr firstRow="1" firstCol="1" bandRow="1"/>
              <a:tblGrid>
                <a:gridCol w="2628900">
                  <a:extLst>
                    <a:ext uri="{9D8B030D-6E8A-4147-A177-3AD203B41FA5}">
                      <a16:colId xmlns:a16="http://schemas.microsoft.com/office/drawing/2014/main" val="2569654801"/>
                    </a:ext>
                  </a:extLst>
                </a:gridCol>
                <a:gridCol w="2628900">
                  <a:extLst>
                    <a:ext uri="{9D8B030D-6E8A-4147-A177-3AD203B41FA5}">
                      <a16:colId xmlns:a16="http://schemas.microsoft.com/office/drawing/2014/main" val="3988799879"/>
                    </a:ext>
                  </a:extLst>
                </a:gridCol>
                <a:gridCol w="2628900">
                  <a:extLst>
                    <a:ext uri="{9D8B030D-6E8A-4147-A177-3AD203B41FA5}">
                      <a16:colId xmlns:a16="http://schemas.microsoft.com/office/drawing/2014/main" val="2680314050"/>
                    </a:ext>
                  </a:extLst>
                </a:gridCol>
                <a:gridCol w="2628900">
                  <a:extLst>
                    <a:ext uri="{9D8B030D-6E8A-4147-A177-3AD203B41FA5}">
                      <a16:colId xmlns:a16="http://schemas.microsoft.com/office/drawing/2014/main" val="110633282"/>
                    </a:ext>
                  </a:extLst>
                </a:gridCol>
              </a:tblGrid>
              <a:tr h="591357">
                <a:tc gridSpan="4"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1" kern="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eneral Model (n=107)</a:t>
                      </a:r>
                      <a:endParaRPr lang="en-US" sz="16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93126741"/>
                  </a:ext>
                </a:extLst>
              </a:tr>
              <a:tr h="59135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1" kern="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UROC – </a:t>
                      </a:r>
                      <a:r>
                        <a:rPr lang="en-US" sz="1800" b="1" kern="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table (n=87)</a:t>
                      </a:r>
                      <a:endParaRPr lang="en-US" sz="16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1" kern="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UROC – Repair (n=17)</a:t>
                      </a:r>
                      <a:endParaRPr lang="en-US" sz="16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1" kern="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UROC – Rupture (n=3)</a:t>
                      </a:r>
                      <a:endParaRPr lang="en-US" sz="16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1" kern="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ccuracy</a:t>
                      </a:r>
                      <a:endParaRPr lang="en-US" sz="16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68412271"/>
                  </a:ext>
                </a:extLst>
              </a:tr>
              <a:tr h="59135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856</a:t>
                      </a:r>
                      <a:endParaRPr lang="en-US" sz="16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843</a:t>
                      </a:r>
                      <a:endParaRPr lang="en-US" sz="16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926</a:t>
                      </a:r>
                      <a:endParaRPr lang="en-US" sz="16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6.4%</a:t>
                      </a:r>
                      <a:endParaRPr lang="en-US" sz="16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54708229"/>
                  </a:ext>
                </a:extLst>
              </a:tr>
              <a:tr h="59135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800</a:t>
                      </a:r>
                      <a:endParaRPr lang="en-US" sz="16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858</a:t>
                      </a:r>
                      <a:endParaRPr lang="en-US" sz="16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907</a:t>
                      </a:r>
                      <a:endParaRPr lang="en-US" sz="16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5.4%</a:t>
                      </a:r>
                      <a:endParaRPr lang="en-US" sz="16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7346972"/>
                  </a:ext>
                </a:extLst>
              </a:tr>
              <a:tr h="59135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785</a:t>
                      </a:r>
                      <a:endParaRPr lang="en-US" sz="16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795</a:t>
                      </a:r>
                      <a:endParaRPr lang="en-US" sz="16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811</a:t>
                      </a:r>
                      <a:endParaRPr lang="en-US" sz="16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7.9%</a:t>
                      </a:r>
                      <a:endParaRPr lang="en-US" sz="16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75495870"/>
                  </a:ext>
                </a:extLst>
              </a:tr>
              <a:tr h="59135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820</a:t>
                      </a:r>
                      <a:endParaRPr lang="en-US" sz="16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943</a:t>
                      </a:r>
                      <a:endParaRPr lang="en-US" sz="16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740</a:t>
                      </a:r>
                      <a:endParaRPr lang="en-US" sz="16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4.5%</a:t>
                      </a:r>
                      <a:endParaRPr lang="en-US" sz="16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06791746"/>
                  </a:ext>
                </a:extLst>
              </a:tr>
              <a:tr h="59135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764</a:t>
                      </a:r>
                      <a:endParaRPr lang="en-US" sz="16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837</a:t>
                      </a:r>
                      <a:endParaRPr lang="en-US" sz="16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712</a:t>
                      </a:r>
                      <a:endParaRPr lang="en-US" sz="16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2.6%</a:t>
                      </a:r>
                      <a:endParaRPr lang="en-US" sz="16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9350410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965188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15837FB-2B8A-B263-8521-15CCF2B3D74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3F2890-4CAD-EFBC-1B7A-AE099D655E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: Comparing Feature Importance Across Models</a:t>
            </a:r>
          </a:p>
        </p:txBody>
      </p:sp>
      <p:pic>
        <p:nvPicPr>
          <p:cNvPr id="8" name="Content Placeholder 7" descr="A graph showing the features of a model&#10;&#10;Description automatically generated">
            <a:extLst>
              <a:ext uri="{FF2B5EF4-FFF2-40B4-BE49-F238E27FC236}">
                <a16:creationId xmlns:a16="http://schemas.microsoft.com/office/drawing/2014/main" id="{AA3D4E46-5AEB-5938-1196-BFC670BB51F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6882" y="1825625"/>
            <a:ext cx="5858235" cy="4351338"/>
          </a:xfrm>
        </p:spPr>
      </p:pic>
    </p:spTree>
    <p:extLst>
      <p:ext uri="{BB962C8B-B14F-4D97-AF65-F5344CB8AC3E}">
        <p14:creationId xmlns:p14="http://schemas.microsoft.com/office/powerpoint/2010/main" val="29612099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9ef9f489-e0a0-4eeb-87cc-3a526112fd0d}" enabled="0" method="" siteId="{9ef9f489-e0a0-4eeb-87cc-3a526112fd0d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5475</TotalTime>
  <Words>74</Words>
  <Application>Microsoft Office PowerPoint</Application>
  <PresentationFormat>Widescreen</PresentationFormat>
  <Paragraphs>2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Supplementary Table 1: Three Outcomes Testing Results</vt:lpstr>
      <vt:lpstr>Supplementary Figure 1: Comparing Feature Importance Across Model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err, Kat</dc:creator>
  <cp:lastModifiedBy>Kerr, Kat</cp:lastModifiedBy>
  <cp:revision>10</cp:revision>
  <dcterms:created xsi:type="dcterms:W3CDTF">2024-09-10T14:54:18Z</dcterms:created>
  <dcterms:modified xsi:type="dcterms:W3CDTF">2025-03-11T18:53:08Z</dcterms:modified>
</cp:coreProperties>
</file>